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3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52250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62809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35315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80448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57966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02166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11633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50959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63731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29203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27114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487FB-69A9-432A-A419-7282600A29EC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09D5B-7A6B-44FE-8D3C-7B0803B7F95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40595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7261223"/>
              </p:ext>
            </p:extLst>
          </p:nvPr>
        </p:nvGraphicFramePr>
        <p:xfrm>
          <a:off x="547507" y="274937"/>
          <a:ext cx="2238736" cy="6072961"/>
        </p:xfrm>
        <a:graphic>
          <a:graphicData uri="http://schemas.openxmlformats.org/drawingml/2006/table">
            <a:tbl>
              <a:tblPr/>
              <a:tblGrid>
                <a:gridCol w="279842"/>
                <a:gridCol w="279842"/>
                <a:gridCol w="279842"/>
                <a:gridCol w="279842"/>
                <a:gridCol w="279842"/>
                <a:gridCol w="279842"/>
                <a:gridCol w="279842"/>
                <a:gridCol w="279842"/>
              </a:tblGrid>
              <a:tr h="87451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5 Table</a:t>
                      </a:r>
                    </a:p>
                  </a:txBody>
                  <a:tcPr marL="4373" marR="4373" marT="43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87451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anges in </a:t>
                      </a:r>
                      <a:r>
                        <a:rPr lang="en-US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</a:t>
                      </a:r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gene expression in mEH KO and sEH KO compared to C57BL/6 WT liver</a:t>
                      </a:r>
                    </a:p>
                  </a:txBody>
                  <a:tcPr marL="4373" marR="4373" marT="437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87451"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H KO compared to WT</a:t>
                      </a:r>
                    </a:p>
                  </a:txBody>
                  <a:tcPr marL="4373" marR="4373" marT="437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H KO compared to WT</a:t>
                      </a:r>
                    </a:p>
                  </a:txBody>
                  <a:tcPr marL="4373" marR="4373" marT="4373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name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g2 Ratio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Value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name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g2 Ratio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Value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5.74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86E-1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46E-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5.69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0E-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80E-1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4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28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6E-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07E-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4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19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6E-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29E-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88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4E-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60E-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34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8E-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92E-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6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76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63E-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07E-0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8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92E-0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1E-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8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8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7E-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340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3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2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e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58E-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0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2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3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j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0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19E-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1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b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14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1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9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26E-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44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7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0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2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3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7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22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4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2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7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0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37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8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7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2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2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7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2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9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7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9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1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3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3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6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0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5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20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7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9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0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6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1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42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2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9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4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2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6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4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5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9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7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2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2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6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0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1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e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6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0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5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8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1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7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6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2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3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14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7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46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6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38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9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5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22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3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73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5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v3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8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6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26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9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8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8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7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7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8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6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1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3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4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5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8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7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8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2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0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5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3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2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50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3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6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0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4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8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7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v3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0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10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26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2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9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2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1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3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18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3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7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6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1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a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4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5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9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6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31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7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4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5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48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9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75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0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43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r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9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7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71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5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69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8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4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3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1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0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37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2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3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77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j6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9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6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7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f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3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78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09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5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24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5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4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02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5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9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48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g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95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2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3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08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4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7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6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28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38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1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8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6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5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5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7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2a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4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28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9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a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0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44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3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5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6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72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7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9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46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3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j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5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98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86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94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7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70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g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89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87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2b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2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s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90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1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2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u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29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54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49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3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9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94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09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7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34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59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54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j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96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1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81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74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9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2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3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99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4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7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04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03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7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24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1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28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6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39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3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1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2a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6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1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4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2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17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61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2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13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17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15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7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2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65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6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3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47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45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25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6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1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7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4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94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90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2b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18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1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42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4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52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d1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57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9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1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80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6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43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94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5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7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29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82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1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33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80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17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b1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68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08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6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22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5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57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s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2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01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29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j6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9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73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f1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07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04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31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u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08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9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f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5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69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4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06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25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97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4a14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14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43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6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j9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10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5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0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76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35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12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87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26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1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0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37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r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086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347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7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02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03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0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0a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18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68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6b1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675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8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3a13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0.009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661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93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7451"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55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13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84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4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b10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0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42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944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87451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CH" sz="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  false discovery rate</a:t>
                      </a:r>
                    </a:p>
                  </a:txBody>
                  <a:tcPr marL="4373" marR="4373" marT="437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373" marR="4373" marT="437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7882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4</Words>
  <Application>Microsoft Office PowerPoint</Application>
  <PresentationFormat>On-screen Show (4:3)</PresentationFormat>
  <Paragraphs>5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ät Züri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Morowsky</dc:creator>
  <cp:lastModifiedBy>Anne Morowsky</cp:lastModifiedBy>
  <cp:revision>1</cp:revision>
  <dcterms:created xsi:type="dcterms:W3CDTF">2017-09-26T13:34:37Z</dcterms:created>
  <dcterms:modified xsi:type="dcterms:W3CDTF">2017-09-26T13:35:39Z</dcterms:modified>
</cp:coreProperties>
</file>